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3658D-DF53-4B02-AF6B-9DD2026EFC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BC73E-01B9-407C-AA14-62A510F28D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E6026-F943-4820-B9A2-0C5E357A3C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20143-51AF-42BA-83D1-5CF306DD61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1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5418E-5B93-469F-97CF-F8641738E5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7273D-567A-4B4E-B0D9-69D6C20863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A015C-2B83-4467-A396-8063DD9A66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B95A3-1CEC-483E-83C3-CB02C57AB7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1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72B8A-AD87-4645-A571-9F3C045695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E3AD2-A239-48D3-BEBB-88264BE10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6B918-3051-48A6-9FDA-567B460CF0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15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4CB0D-0E1A-4E3D-AACC-E7A6B89C7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3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1000"/>
          </a:bodyPr>
          <a:p>
            <a:pPr marL="399600" indent="-399600">
              <a:spcBef>
                <a:spcPts val="11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1" marL="867960" indent="-333000">
              <a:spcBef>
                <a:spcPts val="11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2" marL="1335960" indent="-266040">
              <a:spcBef>
                <a:spcPts val="11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3" marL="1870560" indent="-266040">
              <a:spcBef>
                <a:spcPts val="11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4" marL="2405880" indent="-26604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5" marL="2405880" indent="-26604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  <a:p>
            <a:pPr lvl="6" marL="2405880" indent="-266040">
              <a:spcBef>
                <a:spcPts val="115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E45197-8385-4A73-9359-AF9CE9464665}" type="datetime">
              <a:rPr b="0" lang="ru-RU" sz="17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F1AC40-D2FD-445B-A137-7E99C3D9339B}" type="slidenum">
              <a:rPr b="0" lang="ru-RU" sz="1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Номер слайда 1"/>
          <p:cNvSpPr/>
          <p:nvPr/>
        </p:nvSpPr>
        <p:spPr>
          <a:xfrm>
            <a:off x="491508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Рисунок 4" descr=""/>
          <p:cNvPicPr/>
          <p:nvPr/>
        </p:nvPicPr>
        <p:blipFill>
          <a:blip r:embed="rId1"/>
          <a:stretch/>
        </p:blipFill>
        <p:spPr>
          <a:xfrm>
            <a:off x="1436760" y="920880"/>
            <a:ext cx="3792600" cy="2663640"/>
          </a:xfrm>
          <a:prstGeom prst="rect">
            <a:avLst/>
          </a:prstGeom>
          <a:ln w="0">
            <a:noFill/>
          </a:ln>
        </p:spPr>
      </p:pic>
      <p:sp>
        <p:nvSpPr>
          <p:cNvPr id="43" name="Прямоугольник 2"/>
          <p:cNvSpPr/>
          <p:nvPr/>
        </p:nvSpPr>
        <p:spPr>
          <a:xfrm>
            <a:off x="404640" y="5673600"/>
            <a:ext cx="5688360" cy="173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Figure S1. Rapamycin partially restores the expression of pluripotency genes in LIF-depleted mESC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mRNA expression level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lf4, Nanog, Oct4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ox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s in mESCs grown with LIF (+LIF) and without LIF for 96 h (-LIF). Treatment by rapamycin at concentration of 200 nM during 96 h. Data was obtained by qRT-PCR; the expression level was normalized to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pdh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in each sample. The experiment was repeated three times, the results of one experiment are given with the error bars correspond to the S.E.M. calculated for three replicat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4T11:14:55Z</dcterms:created>
  <dc:creator>Galina</dc:creator>
  <dc:description/>
  <dc:language>en-US</dc:language>
  <cp:lastModifiedBy>ravikumar.n</cp:lastModifiedBy>
  <dcterms:modified xsi:type="dcterms:W3CDTF">2016-01-07T19:07:14Z</dcterms:modified>
  <cp:revision>469</cp:revision>
  <dc:subject/>
  <dc:title>Роль mTOR комплексов в регуляции самообновления и дифференцировки ЭСК мыши</dc:title>
</cp:coreProperties>
</file>